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722"/>
    <p:restoredTop sz="94658"/>
  </p:normalViewPr>
  <p:slideViewPr>
    <p:cSldViewPr snapToGrid="0">
      <p:cViewPr varScale="1">
        <p:scale>
          <a:sx n="80" d="100"/>
          <a:sy n="80" d="100"/>
        </p:scale>
        <p:origin x="25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FC2D2B-AC1F-954B-9C77-4ABFF4E7252C}" type="datetimeFigureOut">
              <a:rPr lang="en-US" smtClean="0"/>
              <a:t>4/16/26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FA8F67-465A-3F43-8E79-C1D44DC6CD1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908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FA8F67-465A-3F43-8E79-C1D44DC6CD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7209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954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049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812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527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965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434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743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574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566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89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656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ABD68C-923C-2E49-954F-A2F1C102D6AE}" type="datetimeFigureOut">
              <a:rPr lang="en-US" smtClean="0"/>
              <a:t>4/16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3C9ACFB-9188-4647-9F3D-EBEBDC8D1250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715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CuadroTexto 25">
            <a:extLst>
              <a:ext uri="{FF2B5EF4-FFF2-40B4-BE49-F238E27FC236}">
                <a16:creationId xmlns:a16="http://schemas.microsoft.com/office/drawing/2014/main" id="{42AACAA5-DAA5-95C3-696C-C918FE756135}"/>
              </a:ext>
            </a:extLst>
          </p:cNvPr>
          <p:cNvSpPr txBox="1"/>
          <p:nvPr/>
        </p:nvSpPr>
        <p:spPr>
          <a:xfrm>
            <a:off x="383929" y="315974"/>
            <a:ext cx="635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3257AD9-C116-B3FF-2585-A479C336D2DD}"/>
              </a:ext>
            </a:extLst>
          </p:cNvPr>
          <p:cNvSpPr txBox="1"/>
          <p:nvPr/>
        </p:nvSpPr>
        <p:spPr>
          <a:xfrm>
            <a:off x="481263" y="4018292"/>
            <a:ext cx="635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pic>
        <p:nvPicPr>
          <p:cNvPr id="33" name="Imagen 32">
            <a:extLst>
              <a:ext uri="{FF2B5EF4-FFF2-40B4-BE49-F238E27FC236}">
                <a16:creationId xmlns:a16="http://schemas.microsoft.com/office/drawing/2014/main" id="{860C9FF5-A490-485A-8C2D-264861619A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0660" y="273875"/>
            <a:ext cx="3278378" cy="3524690"/>
          </a:xfrm>
          <a:prstGeom prst="rect">
            <a:avLst/>
          </a:prstGeom>
        </p:spPr>
      </p:pic>
      <p:pic>
        <p:nvPicPr>
          <p:cNvPr id="37" name="Imagen 36">
            <a:extLst>
              <a:ext uri="{FF2B5EF4-FFF2-40B4-BE49-F238E27FC236}">
                <a16:creationId xmlns:a16="http://schemas.microsoft.com/office/drawing/2014/main" id="{C409B9A4-DDDF-46C6-92CB-09963A5227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0660" y="4143437"/>
            <a:ext cx="3278378" cy="3389392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ED315A88-05C8-2283-5991-3A230C82B9DC}"/>
              </a:ext>
            </a:extLst>
          </p:cNvPr>
          <p:cNvSpPr txBox="1"/>
          <p:nvPr/>
        </p:nvSpPr>
        <p:spPr>
          <a:xfrm>
            <a:off x="248653" y="7782342"/>
            <a:ext cx="6609347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A) Total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ersulfid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B)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ulfenyl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evels in Arabidopsis WT and the H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 mutants. The plant lines were grown in soil under physiological conditions for 25 days, after which protein extracts were obtained. A) Extracts were subjected to in-gel detection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ersulfid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using the dimedone switch method. NBF-Cl was used to react with all the Cys residues and amino groups, resulting in characteristic fluorescence signal representing the loading control, and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ersulfid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dducts were selectively labeled with Daz-2/Cy5-alkyne. The signals were quantified, and the Cy5/NBF-Cl ratios are shown. B) Extracts were subjected to in-gel detection of prote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ulfenyl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evels by labeling with DCP-Bio1 and visualization with Alex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luor</a:t>
            </a:r>
            <a:r>
              <a:rPr lang="en-US" sz="11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488-conjugated streptavidin. The Alexa Fluor 488 signal intensities were normalized to those of the protein loading control (Ponceau staining). The boxplots represent the distribution of biological replicates (n=5), and individual data points are shown. Different letters indicate statistically significant differences (ANOVA, Tukey’s multiple comparisons test; P&lt;0.05).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65238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194</Words>
  <Application>Microsoft Macintosh PowerPoint</Application>
  <PresentationFormat>A4 (210 x 297 mm)</PresentationFormat>
  <Paragraphs>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ecilia Gotor Martínez</dc:creator>
  <cp:lastModifiedBy>Cecilia Gotor Martínez</cp:lastModifiedBy>
  <cp:revision>7</cp:revision>
  <dcterms:created xsi:type="dcterms:W3CDTF">2026-01-08T14:57:02Z</dcterms:created>
  <dcterms:modified xsi:type="dcterms:W3CDTF">2026-04-16T08:56:10Z</dcterms:modified>
</cp:coreProperties>
</file>